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1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100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07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219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5126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4140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694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180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286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792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421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68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E0F91-B922-4FB1-8B09-DCE1EBF6837B}" type="datetimeFigureOut">
              <a:rPr lang="en-US" smtClean="0"/>
              <a:t>7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A4198-319D-42A0-B722-E5F7E1F96F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188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E26C3C2-78F6-404C-B911-2CFC9427F3D5}"/>
              </a:ext>
            </a:extLst>
          </p:cNvPr>
          <p:cNvSpPr txBox="1"/>
          <p:nvPr/>
        </p:nvSpPr>
        <p:spPr>
          <a:xfrm>
            <a:off x="324756" y="447675"/>
            <a:ext cx="440871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2000" b="1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D261B82-2C91-40D0-A264-C22D9C22F140}"/>
              </a:ext>
            </a:extLst>
          </p:cNvPr>
          <p:cNvGrpSpPr/>
          <p:nvPr/>
        </p:nvGrpSpPr>
        <p:grpSpPr>
          <a:xfrm>
            <a:off x="558642" y="1252538"/>
            <a:ext cx="5740717" cy="2539324"/>
            <a:chOff x="988695" y="1252538"/>
            <a:chExt cx="5740717" cy="253932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1C96A09-BE10-4CFB-BBBD-B12B6634C7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3148"/>
            <a:stretch/>
          </p:blipFill>
          <p:spPr>
            <a:xfrm>
              <a:off x="988695" y="1252538"/>
              <a:ext cx="4880610" cy="2539324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C607CA20-EC0A-4C71-A498-5B3A6270FADE}"/>
                </a:ext>
              </a:extLst>
            </p:cNvPr>
            <p:cNvSpPr txBox="1"/>
            <p:nvPr/>
          </p:nvSpPr>
          <p:spPr>
            <a:xfrm>
              <a:off x="4607252" y="1943102"/>
              <a:ext cx="212216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tched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ormal_Femal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CE10F71-77A3-4A02-B5F0-50D053AD89BA}"/>
                </a:ext>
              </a:extLst>
            </p:cNvPr>
            <p:cNvSpPr txBox="1"/>
            <p:nvPr/>
          </p:nvSpPr>
          <p:spPr>
            <a:xfrm>
              <a:off x="4607252" y="2181228"/>
              <a:ext cx="212216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atched 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ormal_Mal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702868B-D14E-429B-AE7C-CDE26E617207}"/>
                </a:ext>
              </a:extLst>
            </p:cNvPr>
            <p:cNvSpPr txBox="1"/>
            <p:nvPr/>
          </p:nvSpPr>
          <p:spPr>
            <a:xfrm>
              <a:off x="4607252" y="2420123"/>
              <a:ext cx="212216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_Femal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DA90E1D-E3BB-435C-81A6-DEDB59B8A4BA}"/>
                </a:ext>
              </a:extLst>
            </p:cNvPr>
            <p:cNvSpPr txBox="1"/>
            <p:nvPr/>
          </p:nvSpPr>
          <p:spPr>
            <a:xfrm>
              <a:off x="4607252" y="2658249"/>
              <a:ext cx="212216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Tumor_Mal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69352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17</Words>
  <Application>Microsoft Office PowerPoint</Application>
  <PresentationFormat>Letter Paper (8.5x11 in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 Bons</dc:creator>
  <cp:lastModifiedBy>Joanna Bons</cp:lastModifiedBy>
  <cp:revision>5</cp:revision>
  <dcterms:created xsi:type="dcterms:W3CDTF">2022-07-19T21:54:15Z</dcterms:created>
  <dcterms:modified xsi:type="dcterms:W3CDTF">2022-07-25T17:40:51Z</dcterms:modified>
</cp:coreProperties>
</file>